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A3D21-5752-44F4-A43B-64D9E2D43C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FD5E5-E9FE-44D6-91B4-B8B081171C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A39A4-4F3E-454F-B635-4F3C594CEC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9C679-23DB-4732-94BB-C78C4E6E8E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1327B-BF30-4017-BFC3-AE1A57A2DD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2FBF6-8C7A-42A1-84EB-98CCC6A32E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C560E-64E6-4E2E-BEBB-0408AEFCAF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274B0-B139-46C7-98EF-55722E99B0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B6BE9-2C23-4784-A939-2027D07906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8FF8C-9397-4230-8830-7842185C1F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A8D69B-E9CC-47C9-9243-4FE92568FC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1C1BB-5617-4530-BDEB-D69AC31878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0C65B1-D9F6-4644-9348-85D00EE9DEC1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1609560" y="-73080"/>
            <a:ext cx="5329440" cy="9219960"/>
            <a:chOff x="1609560" y="-73080"/>
            <a:chExt cx="5329440" cy="9219960"/>
          </a:xfrm>
        </p:grpSpPr>
        <p:sp>
          <p:nvSpPr>
            <p:cNvPr id="42" name="3 Rectángulo"/>
            <p:cNvSpPr/>
            <p:nvPr/>
          </p:nvSpPr>
          <p:spPr>
            <a:xfrm>
              <a:off x="1609560" y="-73080"/>
              <a:ext cx="5329440" cy="921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_Pn2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|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_Pn2||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       |||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|       |||                                   Tryps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 ||       |||                        Ch_lo_Pn1.3_Pn2|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|  ||       |||                       Ch_lo_Pn1.3_Pn2||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| |  ||       |||         Tryps       Ch_lo           |||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|| |  ||       |||             |           |           |||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MKIKNALLSTAAATASLFAIGATAQAATVTVKAGDTVSAIAADHNTTIDAIQQANHLKD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1   ---------+---------+---------+---------+---------+---------+   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_Pn2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   |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_Pn2|   |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||   |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_Pn2|||   |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||||   ||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NLILVGQQLEVNGDSTTTTSTSTQTTQQTTTTQSSAQTSQTQAQPSQASQTQSSQTQTSK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61   ---------+---------+---------+---------+---------+---------+   1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_Pn2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_Pn1.3_Pn2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_Tryps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   |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   |    |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     Pn1.3|   |    |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    Tryps||   |    |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||         |||   |    ||  |  ||  || |  |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AAQTTQTSSSTSNYSNNGSDSAAKAWIAGKESGGSYSARNGQYIGKYQLSASYLNGDY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121   ---------+---------+---------+---------+---------+---------+   18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 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lo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_Pn2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|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Ch_hi_Ch_lo_Pn1.3   ||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Pn1.3|   ||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Tryps   ||   ||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|   ||   || ||   |  ||  ||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AANQERVANSYVASRYGSWSNAKSHWLANGW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          </a:t>
              </a:r>
              <a:r>
                <a:rPr b="0" lang="es-ES" sz="800" spc="-1" strike="noStrike">
                  <a:solidFill>
                    <a:srgbClr val="000000"/>
                  </a:solidFill>
                  <a:latin typeface="Lucida Console"/>
                </a:rPr>
                <a:t>181   ---------+---------+---------+--   21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3" name="6 Conector recto de flecha"/>
            <p:cNvCxnSpPr/>
            <p:nvPr/>
          </p:nvCxnSpPr>
          <p:spPr>
            <a:xfrm>
              <a:off x="3293640" y="3059280"/>
              <a:ext cx="3096360" cy="2160"/>
            </a:xfrm>
            <a:prstGeom prst="straightConnector1">
              <a:avLst/>
            </a:prstGeom>
            <a:ln w="57240">
              <a:solidFill>
                <a:srgbClr val="00b050"/>
              </a:solidFill>
              <a:miter/>
              <a:headEnd len="med" type="triangle" w="med"/>
              <a:tailEnd len="med" type="triangle" w="med"/>
            </a:ln>
          </p:spPr>
        </p:cxnSp>
        <p:cxnSp>
          <p:nvCxnSpPr>
            <p:cNvPr id="44" name="7 Conector recto de flecha"/>
            <p:cNvCxnSpPr/>
            <p:nvPr/>
          </p:nvCxnSpPr>
          <p:spPr>
            <a:xfrm>
              <a:off x="2660400" y="6228360"/>
              <a:ext cx="792720" cy="2160"/>
            </a:xfrm>
            <a:prstGeom prst="straightConnector1">
              <a:avLst/>
            </a:prstGeom>
            <a:ln w="57240">
              <a:solidFill>
                <a:srgbClr val="00b050"/>
              </a:solidFill>
              <a:miter/>
              <a:headEnd len="med" type="triangle" w="med"/>
              <a:tailEnd len="med" type="triangle" w="med"/>
            </a:ln>
          </p:spPr>
        </p:cxnSp>
      </p:grpSp>
      <p:sp>
        <p:nvSpPr>
          <p:cNvPr id="45" name="TextBox 6"/>
          <p:cNvSpPr/>
          <p:nvPr/>
        </p:nvSpPr>
        <p:spPr>
          <a:xfrm>
            <a:off x="0" y="0"/>
            <a:ext cx="266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Suppl.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"/>
          <p:cNvSpPr/>
          <p:nvPr/>
        </p:nvSpPr>
        <p:spPr>
          <a:xfrm>
            <a:off x="0" y="3618720"/>
            <a:ext cx="3357720" cy="17366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  <a:ea typeface="Calibri"/>
              </a:rPr>
              <a:t>ABBREVIAT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* Ch-hi </a:t>
            </a:r>
            <a:r>
              <a:rPr b="1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Chymotrypsin-high specificity (C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erm to [FYW], not before P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* Ch-lo </a:t>
            </a:r>
            <a:r>
              <a:rPr b="1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Chymotrypsin-low specificity (C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erm to [FYWML], not before P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* Pn1.3 </a:t>
            </a:r>
            <a:r>
              <a:rPr b="1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Pepsin (pH1.3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* Pn2 </a:t>
            </a:r>
            <a:r>
              <a:rPr b="1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Pepsin (pH&gt;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* Tryps </a:t>
            </a:r>
            <a:r>
              <a:rPr b="1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Trypsin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7T11:13:01Z</dcterms:created>
  <dc:creator>borja</dc:creator>
  <dc:description/>
  <dc:language>en-US</dc:language>
  <cp:lastModifiedBy>Borja</cp:lastModifiedBy>
  <dcterms:modified xsi:type="dcterms:W3CDTF">2011-10-18T13:35:44Z</dcterms:modified>
  <cp:revision>5</cp:revision>
  <dc:subject/>
  <dc:title>Diapositiva 1</dc:title>
</cp:coreProperties>
</file>